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B0C94-1B81-4104-8759-F7582AD630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C86C0-E2CD-4129-B646-9BD1C53B77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7E22A-7FAB-4456-B08F-8F9FA6B5E1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E1322-17CC-4246-855D-CB0C5AABDD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86B2B-7CA0-42B4-860D-56F091BDF8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82C21-C746-4E16-A867-31EBDE24AC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4E2B0-E270-46A9-8268-BDAB7233D8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58121-385C-4D1B-9316-13A71F63A1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9B9BF-FAC0-43D0-81C4-B05A662D8C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C1259-3230-40CE-8DFC-646BECD6EB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558F8-B033-4A87-85A0-0898481067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E0053-6928-4F48-AFB7-162690BF09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BD5713-7090-470C-8FBF-1694348F7A4C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7"/>
          <p:cNvGrpSpPr/>
          <p:nvPr/>
        </p:nvGrpSpPr>
        <p:grpSpPr>
          <a:xfrm>
            <a:off x="765000" y="971640"/>
            <a:ext cx="2870280" cy="2219400"/>
            <a:chOff x="765000" y="971640"/>
            <a:chExt cx="2870280" cy="2219400"/>
          </a:xfrm>
        </p:grpSpPr>
        <p:sp>
          <p:nvSpPr>
            <p:cNvPr id="42" name="ZoneTexte 3"/>
            <p:cNvSpPr/>
            <p:nvPr/>
          </p:nvSpPr>
          <p:spPr>
            <a:xfrm rot="16200000">
              <a:off x="-2160" y="1746360"/>
              <a:ext cx="1841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umor volume (mm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ZoneTexte 5"/>
            <p:cNvSpPr/>
            <p:nvPr/>
          </p:nvSpPr>
          <p:spPr>
            <a:xfrm>
              <a:off x="1564920" y="2883960"/>
              <a:ext cx="178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ys post-xenograf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Graphique 6" descr=""/>
            <p:cNvPicPr/>
            <p:nvPr/>
          </p:nvPicPr>
          <p:blipFill>
            <a:blip r:embed="rId1"/>
            <a:stretch/>
          </p:blipFill>
          <p:spPr>
            <a:xfrm>
              <a:off x="969120" y="971640"/>
              <a:ext cx="2666160" cy="2070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5" name="ZoneTexte 8"/>
          <p:cNvSpPr/>
          <p:nvPr/>
        </p:nvSpPr>
        <p:spPr>
          <a:xfrm>
            <a:off x="336600" y="3554280"/>
            <a:ext cx="6116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Determination of tumor growth after U87 orthotopic xenoraft.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Tumor volume was determined by µMRI at day 11, 19, 25, 26, 33 after xenograft (N=2 to 10 per date). The initial tumor volume was set at 1µL (corresponding to the volume of cells initially njected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1"/>
          <p:cNvSpPr/>
          <p:nvPr/>
        </p:nvSpPr>
        <p:spPr>
          <a:xfrm>
            <a:off x="3731760" y="4511520"/>
            <a:ext cx="263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4-17T13:41:15Z</dcterms:created>
  <dc:creator>PONCET, DELPHINE</dc:creator>
  <dc:description/>
  <dc:language>en-US</dc:language>
  <cp:lastModifiedBy>PONCET, DELPHINE</cp:lastModifiedBy>
  <dcterms:modified xsi:type="dcterms:W3CDTF">2015-04-17T13:42:07Z</dcterms:modified>
  <cp:revision>1</cp:revision>
  <dc:subject/>
  <dc:title>Présentation PowerPoint</dc:title>
</cp:coreProperties>
</file>